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5240" y="95248"/>
            <a:ext cx="6833148" cy="8714278"/>
            <a:chOff x="15240" y="95248"/>
            <a:chExt cx="6833148" cy="8714278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777" r="2223" b="65852"/>
            <a:stretch/>
          </p:blipFill>
          <p:spPr>
            <a:xfrm>
              <a:off x="4551489" y="5077424"/>
              <a:ext cx="2285867" cy="2545877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55" t="33266" r="27334"/>
            <a:stretch/>
          </p:blipFill>
          <p:spPr>
            <a:xfrm>
              <a:off x="4551489" y="102868"/>
              <a:ext cx="2296899" cy="4975301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55" r="27334" b="66445"/>
            <a:stretch/>
          </p:blipFill>
          <p:spPr>
            <a:xfrm>
              <a:off x="2300310" y="6307860"/>
              <a:ext cx="2296899" cy="2501666"/>
            </a:xfrm>
            <a:prstGeom prst="rect">
              <a:avLst/>
            </a:prstGeom>
          </p:spPr>
        </p:pic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44" r="52334" b="83329"/>
            <a:stretch/>
          </p:blipFill>
          <p:spPr>
            <a:xfrm>
              <a:off x="15240" y="7558290"/>
              <a:ext cx="2307930" cy="124281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44" t="16670" r="52334"/>
            <a:stretch/>
          </p:blipFill>
          <p:spPr>
            <a:xfrm>
              <a:off x="2301979" y="95248"/>
              <a:ext cx="2307930" cy="6212612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6889"/>
            <a:stretch/>
          </p:blipFill>
          <p:spPr>
            <a:xfrm>
              <a:off x="81280" y="95248"/>
              <a:ext cx="2296899" cy="7455422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81280" y="9019137"/>
            <a:ext cx="6720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4. Sequencing depth of the resistant parent GPBD 4.</a:t>
            </a:r>
            <a:r>
              <a:rPr lang="en-US" sz="1200" dirty="0"/>
              <a:t> Black line indicates the sliding window average of 2 Mb interval with 50 kb increment for SNP-index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89955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1</TotalTime>
  <Words>30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0</cp:revision>
  <dcterms:created xsi:type="dcterms:W3CDTF">2015-04-20T11:32:42Z</dcterms:created>
  <dcterms:modified xsi:type="dcterms:W3CDTF">2016-09-26T10:45:39Z</dcterms:modified>
</cp:coreProperties>
</file>